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3D3EB4E-0FDD-DAB9-62B5-5D4BB27E12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2682DAF0-A4E4-7F40-CA35-1F428FAD0B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9127DD6F-8282-D826-742E-4BDF75900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ACE589A8-07C2-D398-5024-84D814B25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03BBE8ED-4132-90C9-D9C1-A14AA0D62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70677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A18142C-CDFE-547F-3C69-4B12251288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6A171963-386D-8D95-5487-EF002306F2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178EA5D-CEED-8F7A-434F-A3B8B72A2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EF3970C-B95F-CE71-BD56-79AE731F5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7AFB0A5-2092-22E5-329D-3CC07FC06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1834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8F90296C-F140-C5D5-3839-44D222BF9F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A9F68C5D-AF0B-00A6-2382-21BEFD512F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B613BAB-988B-B11B-2CAA-44C53106C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4D4BD31-E7B0-2CB8-DBD0-E113E8526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A9BDE5A-DA49-2D4F-AE08-0FDC2C3DD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96030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306890D-953B-A523-D491-7F11DB806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52838409-7F06-49AF-1375-9FAF69F3AC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7BA1735-F4C4-E5BC-C631-087F053E5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D762BD8-419F-7B68-FE0A-D96246A61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2EA530B-D3BB-C24F-1E63-A92F4F983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71500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CFA2DBD-226E-9F87-01DC-4E0CBE7598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A3923EEC-2545-A34E-C388-145E73517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6D1716F-41BC-3A0A-79C9-9FD600D76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4E20AF0-E01B-DCF0-E353-F7FF3A543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524D8FD-7037-A81D-67CF-CB81A477C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03048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911CB4C-2B15-3509-45F7-2DF644714F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F3411103-0948-6130-A09E-941C0219A8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18316E82-BE57-3BF8-74A7-11D4B0C1A3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DA4B0C3F-BF58-D699-510B-7C314233E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86EF3B0B-C6D5-5572-39AF-7E87BF07C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D24B19B3-1C44-EE5A-2E54-7BE1FD226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49160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6051A81-9269-A031-1439-951A50176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3E735BDB-B78C-6A5D-387C-9E948F2F36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039BE8D8-D06E-CA01-0348-C8A09ED7AD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907B9B77-D522-8C56-EB62-7826ACC5A5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112960BD-3823-CB1D-8794-322A75235C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10AE7140-FBD9-81AC-591D-8DDEBCCF8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520E7E60-A060-B8DC-9C33-E70F3D996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75F0E0F3-9A79-AED0-14F1-3B2DCF3C3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13711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CA2F278-0655-A398-F982-468D2E6EBA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6146CBDF-52F2-03AB-FEB4-37DCD6317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7CD74A26-663F-59A7-4AFD-2EE2CFC87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C9E09467-A6FE-5B16-165E-67E685704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96912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5D9A19CE-B9A8-05B5-79B8-68D7A6454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C39B68FF-469A-0288-2C31-DE640D68D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454C1566-9FFE-391A-B50C-EDCCA41484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58426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C8E1726-18C6-98BC-3C9B-42E98B9F05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6B4EF117-5E4C-53D6-C6FD-2B8503E285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76CE4C73-1399-26BF-5064-BF2FE49638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24034B12-3B4D-3E0E-1850-125039B32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80C3718-0B99-1E4D-A5BE-4F02CF65C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A056087C-2178-34D1-9999-525FD44C0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91772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241D0E5-3CC6-BB73-7801-1E21358692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A4550096-2B35-7649-C9A6-92525879B5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2DF7DFFC-5EDD-592F-907A-AEBD2A0CD7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FA50EBCD-5314-6286-2A6A-F239C7064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EFBC52E-3B91-39DA-1EF3-A7A88562A8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AC8AA4DE-44D0-E589-9C32-F95830450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00532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6CE8559C-B575-BF2E-B70B-D19E0B524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DEA01872-7F80-2350-ED99-961E6B4DE1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8E67A6B-F86B-E496-F259-CC5BD46D6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A164B19-A872-2E22-BE5E-9D6EAA68BA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7DFAC13-AB3A-0719-EBE6-7F346631DA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42160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44D2803-8EDB-1298-9545-422ADA58637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571C9207-47EB-6783-9E5F-1CFA9F877E6C}"/>
              </a:ext>
            </a:extLst>
          </p:cNvPr>
          <p:cNvSpPr txBox="1"/>
          <p:nvPr/>
        </p:nvSpPr>
        <p:spPr>
          <a:xfrm>
            <a:off x="69594" y="85297"/>
            <a:ext cx="2126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/>
              <a:t>EMT </a:t>
            </a:r>
            <a:r>
              <a:rPr lang="hu-HU" b="1" dirty="0" err="1"/>
              <a:t>markers</a:t>
            </a:r>
            <a:r>
              <a:rPr lang="hu-HU" b="1" dirty="0"/>
              <a:t>:</a:t>
            </a:r>
          </a:p>
        </p:txBody>
      </p:sp>
      <p:grpSp>
        <p:nvGrpSpPr>
          <p:cNvPr id="15" name="Csoportba foglalás 14">
            <a:extLst>
              <a:ext uri="{FF2B5EF4-FFF2-40B4-BE49-F238E27FC236}">
                <a16:creationId xmlns:a16="http://schemas.microsoft.com/office/drawing/2014/main" id="{5F711854-A4A9-DA55-F8BF-001029BED452}"/>
              </a:ext>
            </a:extLst>
          </p:cNvPr>
          <p:cNvGrpSpPr/>
          <p:nvPr/>
        </p:nvGrpSpPr>
        <p:grpSpPr>
          <a:xfrm>
            <a:off x="113724" y="434568"/>
            <a:ext cx="11964551" cy="2040002"/>
            <a:chOff x="87220" y="397412"/>
            <a:chExt cx="11964551" cy="2040002"/>
          </a:xfrm>
        </p:grpSpPr>
        <p:grpSp>
          <p:nvGrpSpPr>
            <p:cNvPr id="35" name="Csoportba foglalás 34">
              <a:extLst>
                <a:ext uri="{FF2B5EF4-FFF2-40B4-BE49-F238E27FC236}">
                  <a16:creationId xmlns:a16="http://schemas.microsoft.com/office/drawing/2014/main" id="{2E291427-CD84-E11D-3CAB-F1DDF34C8E91}"/>
                </a:ext>
              </a:extLst>
            </p:cNvPr>
            <p:cNvGrpSpPr/>
            <p:nvPr/>
          </p:nvGrpSpPr>
          <p:grpSpPr>
            <a:xfrm>
              <a:off x="87220" y="397412"/>
              <a:ext cx="11964551" cy="2040002"/>
              <a:chOff x="-440692" y="397412"/>
              <a:chExt cx="11964551" cy="2040002"/>
            </a:xfrm>
          </p:grpSpPr>
          <p:grpSp>
            <p:nvGrpSpPr>
              <p:cNvPr id="51" name="Csoportba foglalás 50">
                <a:extLst>
                  <a:ext uri="{FF2B5EF4-FFF2-40B4-BE49-F238E27FC236}">
                    <a16:creationId xmlns:a16="http://schemas.microsoft.com/office/drawing/2014/main" id="{C434AB6E-2129-13AD-DCA5-D9322E0FA5B2}"/>
                  </a:ext>
                </a:extLst>
              </p:cNvPr>
              <p:cNvGrpSpPr/>
              <p:nvPr/>
            </p:nvGrpSpPr>
            <p:grpSpPr>
              <a:xfrm>
                <a:off x="-440692" y="397412"/>
                <a:ext cx="11964551" cy="2040002"/>
                <a:chOff x="-440692" y="397412"/>
                <a:chExt cx="11964551" cy="2040002"/>
              </a:xfrm>
            </p:grpSpPr>
            <p:grpSp>
              <p:nvGrpSpPr>
                <p:cNvPr id="53" name="Csoportba foglalás 52">
                  <a:extLst>
                    <a:ext uri="{FF2B5EF4-FFF2-40B4-BE49-F238E27FC236}">
                      <a16:creationId xmlns:a16="http://schemas.microsoft.com/office/drawing/2014/main" id="{F5F91E73-6658-0D67-98E6-CCEF64B04F35}"/>
                    </a:ext>
                  </a:extLst>
                </p:cNvPr>
                <p:cNvGrpSpPr/>
                <p:nvPr/>
              </p:nvGrpSpPr>
              <p:grpSpPr>
                <a:xfrm>
                  <a:off x="-440692" y="397412"/>
                  <a:ext cx="11964551" cy="2040002"/>
                  <a:chOff x="-440692" y="397412"/>
                  <a:chExt cx="11964551" cy="2040002"/>
                </a:xfrm>
              </p:grpSpPr>
              <p:grpSp>
                <p:nvGrpSpPr>
                  <p:cNvPr id="63" name="Csoportba foglalás 62">
                    <a:extLst>
                      <a:ext uri="{FF2B5EF4-FFF2-40B4-BE49-F238E27FC236}">
                        <a16:creationId xmlns:a16="http://schemas.microsoft.com/office/drawing/2014/main" id="{3BD27486-3DD2-5CC4-D40B-86039ACCF3AE}"/>
                      </a:ext>
                    </a:extLst>
                  </p:cNvPr>
                  <p:cNvGrpSpPr/>
                  <p:nvPr/>
                </p:nvGrpSpPr>
                <p:grpSpPr>
                  <a:xfrm>
                    <a:off x="-440692" y="397412"/>
                    <a:ext cx="11964551" cy="2040002"/>
                    <a:chOff x="-440692" y="397412"/>
                    <a:chExt cx="11964551" cy="2040002"/>
                  </a:xfrm>
                </p:grpSpPr>
                <p:grpSp>
                  <p:nvGrpSpPr>
                    <p:cNvPr id="66" name="Csoportba foglalás 65">
                      <a:extLst>
                        <a:ext uri="{FF2B5EF4-FFF2-40B4-BE49-F238E27FC236}">
                          <a16:creationId xmlns:a16="http://schemas.microsoft.com/office/drawing/2014/main" id="{4858543C-6332-7493-FC1E-08D9DC9616B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440692" y="397412"/>
                      <a:ext cx="11964551" cy="2040002"/>
                      <a:chOff x="-440692" y="397412"/>
                      <a:chExt cx="11964551" cy="2040002"/>
                    </a:xfrm>
                  </p:grpSpPr>
                  <p:grpSp>
                    <p:nvGrpSpPr>
                      <p:cNvPr id="70" name="Csoportba foglalás 69">
                        <a:extLst>
                          <a:ext uri="{FF2B5EF4-FFF2-40B4-BE49-F238E27FC236}">
                            <a16:creationId xmlns:a16="http://schemas.microsoft.com/office/drawing/2014/main" id="{724D91D8-914C-3FC4-A8CB-2063B2EF52A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440692" y="397412"/>
                        <a:ext cx="11964551" cy="2040002"/>
                        <a:chOff x="-440692" y="397412"/>
                        <a:chExt cx="11964551" cy="2040002"/>
                      </a:xfrm>
                    </p:grpSpPr>
                    <p:grpSp>
                      <p:nvGrpSpPr>
                        <p:cNvPr id="77" name="Csoportba foglalás 76">
                          <a:extLst>
                            <a:ext uri="{FF2B5EF4-FFF2-40B4-BE49-F238E27FC236}">
                              <a16:creationId xmlns:a16="http://schemas.microsoft.com/office/drawing/2014/main" id="{8F4107C4-8D8C-EB8D-4E79-2AC4AF94DB5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440692" y="397412"/>
                          <a:ext cx="11964551" cy="2040002"/>
                          <a:chOff x="-440692" y="397412"/>
                          <a:chExt cx="11964551" cy="2040002"/>
                        </a:xfrm>
                      </p:grpSpPr>
                      <p:grpSp>
                        <p:nvGrpSpPr>
                          <p:cNvPr id="86" name="Csoportba foglalás 85">
                            <a:extLst>
                              <a:ext uri="{FF2B5EF4-FFF2-40B4-BE49-F238E27FC236}">
                                <a16:creationId xmlns:a16="http://schemas.microsoft.com/office/drawing/2014/main" id="{F4F0A7FF-84BD-6BED-9C4B-77AD5A4190A4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-440692" y="397412"/>
                            <a:ext cx="11964551" cy="2040002"/>
                            <a:chOff x="-440692" y="434619"/>
                            <a:chExt cx="11964551" cy="2040002"/>
                          </a:xfrm>
                        </p:grpSpPr>
                        <p:sp>
                          <p:nvSpPr>
                            <p:cNvPr id="89" name="Szövegdoboz 88">
                              <a:extLst>
                                <a:ext uri="{FF2B5EF4-FFF2-40B4-BE49-F238E27FC236}">
                                  <a16:creationId xmlns:a16="http://schemas.microsoft.com/office/drawing/2014/main" id="{5ACCA9E3-550A-15D1-FFB7-39C543F5F0F4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-440692" y="1048238"/>
                              <a:ext cx="1604601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hu-HU" sz="1400" dirty="0"/>
                                <a:t>E-</a:t>
                              </a:r>
                              <a:r>
                                <a:rPr lang="hu-HU" sz="1400" dirty="0" err="1"/>
                                <a:t>cadherin</a:t>
                              </a:r>
                              <a:r>
                                <a:rPr lang="hu-HU" sz="1400" dirty="0"/>
                                <a:t>:</a:t>
                              </a:r>
                            </a:p>
                          </p:txBody>
                        </p:sp>
                        <p:sp>
                          <p:nvSpPr>
                            <p:cNvPr id="91" name="Szövegdoboz 90">
                              <a:extLst>
                                <a:ext uri="{FF2B5EF4-FFF2-40B4-BE49-F238E27FC236}">
                                  <a16:creationId xmlns:a16="http://schemas.microsoft.com/office/drawing/2014/main" id="{2F31C4C0-B2BF-76BA-E24C-D5D795A277E9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-440691" y="1947525"/>
                              <a:ext cx="1197412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hu-HU" sz="1400" dirty="0"/>
                                <a:t>β-</a:t>
                              </a:r>
                              <a:r>
                                <a:rPr lang="hu-HU" sz="1400" dirty="0" err="1"/>
                                <a:t>actin</a:t>
                              </a:r>
                              <a:r>
                                <a:rPr lang="hu-HU" sz="1400" dirty="0"/>
                                <a:t>:</a:t>
                              </a:r>
                            </a:p>
                          </p:txBody>
                        </p:sp>
                        <p:sp>
                          <p:nvSpPr>
                            <p:cNvPr id="92" name="Szövegdoboz 91">
                              <a:extLst>
                                <a:ext uri="{FF2B5EF4-FFF2-40B4-BE49-F238E27FC236}">
                                  <a16:creationId xmlns:a16="http://schemas.microsoft.com/office/drawing/2014/main" id="{40C56476-2D60-D4C5-7923-BC629A8855AD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309795" y="463703"/>
                              <a:ext cx="332142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1400" b="1" dirty="0"/>
                                <a:t>1.</a:t>
                              </a:r>
                            </a:p>
                          </p:txBody>
                        </p:sp>
                        <p:sp>
                          <p:nvSpPr>
                            <p:cNvPr id="96" name="Szövegdoboz 95">
                              <a:extLst>
                                <a:ext uri="{FF2B5EF4-FFF2-40B4-BE49-F238E27FC236}">
                                  <a16:creationId xmlns:a16="http://schemas.microsoft.com/office/drawing/2014/main" id="{C3FC8F71-C369-EB78-D89A-33A35741B8C4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2229102" y="447575"/>
                              <a:ext cx="335348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1400" b="1" dirty="0"/>
                                <a:t>2.</a:t>
                              </a:r>
                            </a:p>
                          </p:txBody>
                        </p:sp>
                        <p:sp>
                          <p:nvSpPr>
                            <p:cNvPr id="99" name="Szövegdoboz 98">
                              <a:extLst>
                                <a:ext uri="{FF2B5EF4-FFF2-40B4-BE49-F238E27FC236}">
                                  <a16:creationId xmlns:a16="http://schemas.microsoft.com/office/drawing/2014/main" id="{8E2307DB-3CB6-AE49-1C35-4F118521B2BE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2945552" y="434619"/>
                              <a:ext cx="335348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1400" b="1" dirty="0"/>
                                <a:t>3.</a:t>
                              </a:r>
                            </a:p>
                          </p:txBody>
                        </p:sp>
                        <p:sp>
                          <p:nvSpPr>
                            <p:cNvPr id="107" name="Téglalap 106">
                              <a:extLst>
                                <a:ext uri="{FF2B5EF4-FFF2-40B4-BE49-F238E27FC236}">
                                  <a16:creationId xmlns:a16="http://schemas.microsoft.com/office/drawing/2014/main" id="{902ADA40-E02C-3514-89B7-E21E56A65E6E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-438236" y="474905"/>
                              <a:ext cx="11962095" cy="1999716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style>
                            <a:lnRef idx="2">
                              <a:schemeClr val="accent1">
                                <a:shade val="1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hu-HU"/>
                            </a:p>
                          </p:txBody>
                        </p:sp>
                      </p:grpSp>
                      <p:sp>
                        <p:nvSpPr>
                          <p:cNvPr id="82" name="Szövegdoboz 81">
                            <a:extLst>
                              <a:ext uri="{FF2B5EF4-FFF2-40B4-BE49-F238E27FC236}">
                                <a16:creationId xmlns:a16="http://schemas.microsoft.com/office/drawing/2014/main" id="{3B410594-8B2A-02E7-DBCA-D03E1D4AB23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368165" y="713478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85" name="Szövegdoboz 84">
                            <a:extLst>
                              <a:ext uri="{FF2B5EF4-FFF2-40B4-BE49-F238E27FC236}">
                                <a16:creationId xmlns:a16="http://schemas.microsoft.com/office/drawing/2014/main" id="{BE0BF1FE-340D-9735-D4F3-4533F83F40C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822849" y="717463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</p:grpSp>
                    <p:sp>
                      <p:nvSpPr>
                        <p:cNvPr id="79" name="Szövegdoboz 78">
                          <a:extLst>
                            <a:ext uri="{FF2B5EF4-FFF2-40B4-BE49-F238E27FC236}">
                              <a16:creationId xmlns:a16="http://schemas.microsoft.com/office/drawing/2014/main" id="{C572384E-AB6E-EA28-71D7-0DD7E6CFB96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939217" y="1060564"/>
                          <a:ext cx="348172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130</a:t>
                          </a:r>
                        </a:p>
                      </p:txBody>
                    </p:sp>
                    <p:sp>
                      <p:nvSpPr>
                        <p:cNvPr id="80" name="Szövegdoboz 79">
                          <a:extLst>
                            <a:ext uri="{FF2B5EF4-FFF2-40B4-BE49-F238E27FC236}">
                              <a16:creationId xmlns:a16="http://schemas.microsoft.com/office/drawing/2014/main" id="{937F6EAF-DAAB-E6F4-BB03-EB5093F0CD0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979179" y="1270793"/>
                          <a:ext cx="184731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endParaRPr lang="hu-HU" sz="800" dirty="0"/>
                        </a:p>
                      </p:txBody>
                    </p:sp>
                  </p:grpSp>
                  <p:sp>
                    <p:nvSpPr>
                      <p:cNvPr id="71" name="Szövegdoboz 70">
                        <a:extLst>
                          <a:ext uri="{FF2B5EF4-FFF2-40B4-BE49-F238E27FC236}">
                            <a16:creationId xmlns:a16="http://schemas.microsoft.com/office/drawing/2014/main" id="{5C8654A8-10A3-BE8E-619B-BB0CCBCEF9F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461566" y="1610999"/>
                        <a:ext cx="47000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DMSO</a:t>
                        </a:r>
                      </a:p>
                    </p:txBody>
                  </p:sp>
                  <p:sp>
                    <p:nvSpPr>
                      <p:cNvPr id="75" name="Szövegdoboz 74">
                        <a:extLst>
                          <a:ext uri="{FF2B5EF4-FFF2-40B4-BE49-F238E27FC236}">
                            <a16:creationId xmlns:a16="http://schemas.microsoft.com/office/drawing/2014/main" id="{90DAE1F5-D42A-244E-0DA7-191E5869698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43284" y="1605394"/>
                        <a:ext cx="45717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UDCA</a:t>
                        </a:r>
                      </a:p>
                    </p:txBody>
                  </p:sp>
                </p:grpSp>
                <p:sp>
                  <p:nvSpPr>
                    <p:cNvPr id="69" name="Szövegdoboz 68">
                      <a:extLst>
                        <a:ext uri="{FF2B5EF4-FFF2-40B4-BE49-F238E27FC236}">
                          <a16:creationId xmlns:a16="http://schemas.microsoft.com/office/drawing/2014/main" id="{1BF67F41-6F88-60A7-CAF0-F11EC352E30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6721" y="2077691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35</a:t>
                      </a:r>
                    </a:p>
                  </p:txBody>
                </p:sp>
              </p:grpSp>
              <p:sp>
                <p:nvSpPr>
                  <p:cNvPr id="61" name="Szövegdoboz 60">
                    <a:extLst>
                      <a:ext uri="{FF2B5EF4-FFF2-40B4-BE49-F238E27FC236}">
                        <a16:creationId xmlns:a16="http://schemas.microsoft.com/office/drawing/2014/main" id="{E1DD54FE-F0B3-BCB7-2B59-21F131190B78}"/>
                      </a:ext>
                    </a:extLst>
                  </p:cNvPr>
                  <p:cNvSpPr txBox="1"/>
                  <p:nvPr/>
                </p:nvSpPr>
                <p:spPr>
                  <a:xfrm>
                    <a:off x="4799257" y="946039"/>
                    <a:ext cx="3481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130</a:t>
                    </a:r>
                  </a:p>
                </p:txBody>
              </p:sp>
            </p:grpSp>
            <p:sp>
              <p:nvSpPr>
                <p:cNvPr id="56" name="Szövegdoboz 55">
                  <a:extLst>
                    <a:ext uri="{FF2B5EF4-FFF2-40B4-BE49-F238E27FC236}">
                      <a16:creationId xmlns:a16="http://schemas.microsoft.com/office/drawing/2014/main" id="{D282392F-D4B5-CDC2-254F-0353B7318B4B}"/>
                    </a:ext>
                  </a:extLst>
                </p:cNvPr>
                <p:cNvSpPr txBox="1"/>
                <p:nvPr/>
              </p:nvSpPr>
              <p:spPr>
                <a:xfrm>
                  <a:off x="7745577" y="728670"/>
                  <a:ext cx="4700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DMSO</a:t>
                  </a:r>
                </a:p>
              </p:txBody>
            </p:sp>
            <p:sp>
              <p:nvSpPr>
                <p:cNvPr id="58" name="Szövegdoboz 57">
                  <a:extLst>
                    <a:ext uri="{FF2B5EF4-FFF2-40B4-BE49-F238E27FC236}">
                      <a16:creationId xmlns:a16="http://schemas.microsoft.com/office/drawing/2014/main" id="{D0F05266-37DE-594E-4347-28E2B9447E7B}"/>
                    </a:ext>
                  </a:extLst>
                </p:cNvPr>
                <p:cNvSpPr txBox="1"/>
                <p:nvPr/>
              </p:nvSpPr>
              <p:spPr>
                <a:xfrm>
                  <a:off x="8137075" y="728670"/>
                  <a:ext cx="45717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UDCA</a:t>
                  </a:r>
                </a:p>
              </p:txBody>
            </p:sp>
          </p:grpSp>
          <p:sp>
            <p:nvSpPr>
              <p:cNvPr id="46" name="Szövegdoboz 45">
                <a:extLst>
                  <a:ext uri="{FF2B5EF4-FFF2-40B4-BE49-F238E27FC236}">
                    <a16:creationId xmlns:a16="http://schemas.microsoft.com/office/drawing/2014/main" id="{B6DD2DFD-07EF-A885-AD3C-BD2092D0B2AE}"/>
                  </a:ext>
                </a:extLst>
              </p:cNvPr>
              <p:cNvSpPr txBox="1"/>
              <p:nvPr/>
            </p:nvSpPr>
            <p:spPr>
              <a:xfrm>
                <a:off x="4941377" y="1857049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55</a:t>
                </a:r>
              </a:p>
            </p:txBody>
          </p:sp>
        </p:grpSp>
        <p:sp>
          <p:nvSpPr>
            <p:cNvPr id="23" name="Szövegdoboz 22">
              <a:extLst>
                <a:ext uri="{FF2B5EF4-FFF2-40B4-BE49-F238E27FC236}">
                  <a16:creationId xmlns:a16="http://schemas.microsoft.com/office/drawing/2014/main" id="{C95E234A-A404-3EA3-5141-C57B95FC28C3}"/>
                </a:ext>
              </a:extLst>
            </p:cNvPr>
            <p:cNvSpPr txBox="1"/>
            <p:nvPr/>
          </p:nvSpPr>
          <p:spPr>
            <a:xfrm>
              <a:off x="3507030" y="711402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DMSO</a:t>
              </a:r>
            </a:p>
          </p:txBody>
        </p:sp>
        <p:sp>
          <p:nvSpPr>
            <p:cNvPr id="24" name="Szövegdoboz 23">
              <a:extLst>
                <a:ext uri="{FF2B5EF4-FFF2-40B4-BE49-F238E27FC236}">
                  <a16:creationId xmlns:a16="http://schemas.microsoft.com/office/drawing/2014/main" id="{FDB81023-A955-6C0C-6DB5-688EED89759D}"/>
                </a:ext>
              </a:extLst>
            </p:cNvPr>
            <p:cNvSpPr txBox="1"/>
            <p:nvPr/>
          </p:nvSpPr>
          <p:spPr>
            <a:xfrm>
              <a:off x="3901801" y="704219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UDCA</a:t>
              </a:r>
            </a:p>
          </p:txBody>
        </p:sp>
      </p:grpSp>
      <p:sp>
        <p:nvSpPr>
          <p:cNvPr id="154" name="Szövegdoboz 153">
            <a:extLst>
              <a:ext uri="{FF2B5EF4-FFF2-40B4-BE49-F238E27FC236}">
                <a16:creationId xmlns:a16="http://schemas.microsoft.com/office/drawing/2014/main" id="{19435854-C484-5C1D-9892-B3532FCD33F9}"/>
              </a:ext>
            </a:extLst>
          </p:cNvPr>
          <p:cNvSpPr txBox="1"/>
          <p:nvPr/>
        </p:nvSpPr>
        <p:spPr>
          <a:xfrm>
            <a:off x="3126903" y="753552"/>
            <a:ext cx="4571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UDCA</a:t>
            </a:r>
          </a:p>
        </p:txBody>
      </p:sp>
      <p:sp>
        <p:nvSpPr>
          <p:cNvPr id="156" name="Szövegdoboz 155">
            <a:extLst>
              <a:ext uri="{FF2B5EF4-FFF2-40B4-BE49-F238E27FC236}">
                <a16:creationId xmlns:a16="http://schemas.microsoft.com/office/drawing/2014/main" id="{DC176E75-B25D-2345-6DC0-0EF7F0BA587A}"/>
              </a:ext>
            </a:extLst>
          </p:cNvPr>
          <p:cNvSpPr txBox="1"/>
          <p:nvPr/>
        </p:nvSpPr>
        <p:spPr>
          <a:xfrm>
            <a:off x="2767586" y="746140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DMSO</a:t>
            </a:r>
          </a:p>
        </p:txBody>
      </p:sp>
      <p:sp>
        <p:nvSpPr>
          <p:cNvPr id="157" name="Szövegdoboz 156">
            <a:extLst>
              <a:ext uri="{FF2B5EF4-FFF2-40B4-BE49-F238E27FC236}">
                <a16:creationId xmlns:a16="http://schemas.microsoft.com/office/drawing/2014/main" id="{0239E681-6EE2-5CD4-B1BB-ACE7AFA21BAB}"/>
              </a:ext>
            </a:extLst>
          </p:cNvPr>
          <p:cNvSpPr txBox="1"/>
          <p:nvPr/>
        </p:nvSpPr>
        <p:spPr>
          <a:xfrm>
            <a:off x="8286895" y="479321"/>
            <a:ext cx="335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4.</a:t>
            </a:r>
          </a:p>
        </p:txBody>
      </p:sp>
      <p:sp>
        <p:nvSpPr>
          <p:cNvPr id="182" name="Szövegdoboz 181">
            <a:extLst>
              <a:ext uri="{FF2B5EF4-FFF2-40B4-BE49-F238E27FC236}">
                <a16:creationId xmlns:a16="http://schemas.microsoft.com/office/drawing/2014/main" id="{6D549628-566F-A624-F5F3-19EBF0F38CBB}"/>
              </a:ext>
            </a:extLst>
          </p:cNvPr>
          <p:cNvSpPr txBox="1"/>
          <p:nvPr/>
        </p:nvSpPr>
        <p:spPr>
          <a:xfrm>
            <a:off x="5495793" y="2185422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35</a:t>
            </a:r>
          </a:p>
        </p:txBody>
      </p:sp>
      <p:sp>
        <p:nvSpPr>
          <p:cNvPr id="183" name="Szövegdoboz 182">
            <a:extLst>
              <a:ext uri="{FF2B5EF4-FFF2-40B4-BE49-F238E27FC236}">
                <a16:creationId xmlns:a16="http://schemas.microsoft.com/office/drawing/2014/main" id="{59BC8505-209C-C120-1F3A-0EA160F2A9C0}"/>
              </a:ext>
            </a:extLst>
          </p:cNvPr>
          <p:cNvSpPr txBox="1"/>
          <p:nvPr/>
        </p:nvSpPr>
        <p:spPr>
          <a:xfrm>
            <a:off x="8780890" y="1631484"/>
            <a:ext cx="4571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UDCA</a:t>
            </a:r>
          </a:p>
        </p:txBody>
      </p:sp>
      <p:sp>
        <p:nvSpPr>
          <p:cNvPr id="184" name="Szövegdoboz 183">
            <a:extLst>
              <a:ext uri="{FF2B5EF4-FFF2-40B4-BE49-F238E27FC236}">
                <a16:creationId xmlns:a16="http://schemas.microsoft.com/office/drawing/2014/main" id="{E58CB2A7-8785-3B6B-F514-B3D86C66A359}"/>
              </a:ext>
            </a:extLst>
          </p:cNvPr>
          <p:cNvSpPr txBox="1"/>
          <p:nvPr/>
        </p:nvSpPr>
        <p:spPr>
          <a:xfrm>
            <a:off x="8387243" y="163788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DMSO</a:t>
            </a:r>
          </a:p>
        </p:txBody>
      </p:sp>
      <p:pic>
        <p:nvPicPr>
          <p:cNvPr id="20" name="Kép 19" descr="A képen éjszaka, fekete-fehér látható&#10;&#10;Automatikusan generált leírás közepes megbízhatósággal">
            <a:extLst>
              <a:ext uri="{FF2B5EF4-FFF2-40B4-BE49-F238E27FC236}">
                <a16:creationId xmlns:a16="http://schemas.microsoft.com/office/drawing/2014/main" id="{5C006E9A-ADE4-8DB8-E289-396821F7840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249" r="23046" b="35317"/>
          <a:stretch/>
        </p:blipFill>
        <p:spPr>
          <a:xfrm>
            <a:off x="1783148" y="981270"/>
            <a:ext cx="3552445" cy="533285"/>
          </a:xfrm>
          <a:prstGeom prst="rect">
            <a:avLst/>
          </a:prstGeom>
        </p:spPr>
      </p:pic>
      <p:pic>
        <p:nvPicPr>
          <p:cNvPr id="25" name="Kép 24" descr="A képen fekete, monokróm, fekete-fehér, Monokróm fényképezés látható&#10;&#10;Automatikusan generált leírás">
            <a:extLst>
              <a:ext uri="{FF2B5EF4-FFF2-40B4-BE49-F238E27FC236}">
                <a16:creationId xmlns:a16="http://schemas.microsoft.com/office/drawing/2014/main" id="{41EE6F79-0CE3-8C9B-AA16-32A9143D517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146" r="8144" b="23788"/>
          <a:stretch/>
        </p:blipFill>
        <p:spPr>
          <a:xfrm>
            <a:off x="5642628" y="961129"/>
            <a:ext cx="3552445" cy="533284"/>
          </a:xfrm>
          <a:prstGeom prst="rect">
            <a:avLst/>
          </a:prstGeom>
        </p:spPr>
      </p:pic>
      <p:pic>
        <p:nvPicPr>
          <p:cNvPr id="31" name="Kép 30" descr="A képen Téglalap, képernyőkép, fekete, sor látható&#10;&#10;Automatikusan generált leírás">
            <a:extLst>
              <a:ext uri="{FF2B5EF4-FFF2-40B4-BE49-F238E27FC236}">
                <a16:creationId xmlns:a16="http://schemas.microsoft.com/office/drawing/2014/main" id="{83EE0935-4D67-C3EE-E378-A28C3EF4BB8E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07" t="37505" r="15422" b="40112"/>
          <a:stretch/>
        </p:blipFill>
        <p:spPr>
          <a:xfrm>
            <a:off x="5711072" y="1808523"/>
            <a:ext cx="3552445" cy="612648"/>
          </a:xfrm>
          <a:prstGeom prst="rect">
            <a:avLst/>
          </a:prstGeom>
        </p:spPr>
      </p:pic>
      <p:pic>
        <p:nvPicPr>
          <p:cNvPr id="52" name="Kép 51" descr="A képen fekete, fekete-fehér, Téglalap, sor látható&#10;&#10;Automatikusan generált leírás">
            <a:extLst>
              <a:ext uri="{FF2B5EF4-FFF2-40B4-BE49-F238E27FC236}">
                <a16:creationId xmlns:a16="http://schemas.microsoft.com/office/drawing/2014/main" id="{5B092D29-B97C-449A-0E6B-6196D5669C69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59" t="36048" r="10285" b="42697"/>
          <a:stretch/>
        </p:blipFill>
        <p:spPr>
          <a:xfrm>
            <a:off x="1783148" y="1848659"/>
            <a:ext cx="3528886" cy="581762"/>
          </a:xfrm>
          <a:prstGeom prst="rect">
            <a:avLst/>
          </a:prstGeom>
        </p:spPr>
      </p:pic>
      <p:sp>
        <p:nvSpPr>
          <p:cNvPr id="62" name="Szövegdoboz 61">
            <a:extLst>
              <a:ext uri="{FF2B5EF4-FFF2-40B4-BE49-F238E27FC236}">
                <a16:creationId xmlns:a16="http://schemas.microsoft.com/office/drawing/2014/main" id="{9C246C27-B2E6-245F-AE28-C0350133D124}"/>
              </a:ext>
            </a:extLst>
          </p:cNvPr>
          <p:cNvSpPr txBox="1"/>
          <p:nvPr/>
        </p:nvSpPr>
        <p:spPr>
          <a:xfrm>
            <a:off x="2783914" y="163788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DMSO</a:t>
            </a:r>
          </a:p>
        </p:txBody>
      </p:sp>
      <p:sp>
        <p:nvSpPr>
          <p:cNvPr id="64" name="Szövegdoboz 63">
            <a:extLst>
              <a:ext uri="{FF2B5EF4-FFF2-40B4-BE49-F238E27FC236}">
                <a16:creationId xmlns:a16="http://schemas.microsoft.com/office/drawing/2014/main" id="{22B1B547-751C-0EE7-C4AD-311AF35689A8}"/>
              </a:ext>
            </a:extLst>
          </p:cNvPr>
          <p:cNvSpPr txBox="1"/>
          <p:nvPr/>
        </p:nvSpPr>
        <p:spPr>
          <a:xfrm>
            <a:off x="3145383" y="1646728"/>
            <a:ext cx="4571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UDCA</a:t>
            </a:r>
          </a:p>
        </p:txBody>
      </p:sp>
      <p:sp>
        <p:nvSpPr>
          <p:cNvPr id="81" name="Szövegdoboz 80">
            <a:extLst>
              <a:ext uri="{FF2B5EF4-FFF2-40B4-BE49-F238E27FC236}">
                <a16:creationId xmlns:a16="http://schemas.microsoft.com/office/drawing/2014/main" id="{421B89EE-141A-F413-0F70-822BBFCEA4F2}"/>
              </a:ext>
            </a:extLst>
          </p:cNvPr>
          <p:cNvSpPr txBox="1"/>
          <p:nvPr/>
        </p:nvSpPr>
        <p:spPr>
          <a:xfrm>
            <a:off x="3582813" y="163788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DMSO</a:t>
            </a:r>
          </a:p>
        </p:txBody>
      </p:sp>
      <p:sp>
        <p:nvSpPr>
          <p:cNvPr id="87" name="Szövegdoboz 86">
            <a:extLst>
              <a:ext uri="{FF2B5EF4-FFF2-40B4-BE49-F238E27FC236}">
                <a16:creationId xmlns:a16="http://schemas.microsoft.com/office/drawing/2014/main" id="{C7545E04-7F6D-159C-1260-D265B074EE37}"/>
              </a:ext>
            </a:extLst>
          </p:cNvPr>
          <p:cNvSpPr txBox="1"/>
          <p:nvPr/>
        </p:nvSpPr>
        <p:spPr>
          <a:xfrm>
            <a:off x="3945898" y="1642550"/>
            <a:ext cx="4571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UDCA</a:t>
            </a:r>
          </a:p>
        </p:txBody>
      </p:sp>
    </p:spTree>
    <p:extLst>
      <p:ext uri="{BB962C8B-B14F-4D97-AF65-F5344CB8AC3E}">
        <p14:creationId xmlns:p14="http://schemas.microsoft.com/office/powerpoint/2010/main" val="2209522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26</TotalTime>
  <Words>36</Words>
  <Application>Microsoft Office PowerPoint</Application>
  <PresentationFormat>Szélesvásznú</PresentationFormat>
  <Paragraphs>28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Patrik</dc:creator>
  <cp:lastModifiedBy>Edit</cp:lastModifiedBy>
  <cp:revision>181</cp:revision>
  <dcterms:created xsi:type="dcterms:W3CDTF">2024-03-11T09:39:17Z</dcterms:created>
  <dcterms:modified xsi:type="dcterms:W3CDTF">2024-11-21T11:14:16Z</dcterms:modified>
</cp:coreProperties>
</file>